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3" autoAdjust="0"/>
    <p:restoredTop sz="74697" autoAdjust="0"/>
  </p:normalViewPr>
  <p:slideViewPr>
    <p:cSldViewPr snapToGrid="0" showGuides="1">
      <p:cViewPr varScale="1">
        <p:scale>
          <a:sx n="79" d="100"/>
          <a:sy n="79" d="100"/>
        </p:scale>
        <p:origin x="1752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17.%20Taxonomy\3.%20Fibrella\20151220%20Fib%20radi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17.%20Taxonomy\3.%20Fibrella\6.%20AOM\2022%20Fib%20radi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G$31</c:f>
              <c:strCache>
                <c:ptCount val="1"/>
                <c:pt idx="0">
                  <c:v>ES10-3-2-2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32:$M$3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0.265310055243994</c:v>
                  </c:pt>
                  <c:pt idx="2">
                    <c:v>18.679860097145525</c:v>
                  </c:pt>
                  <c:pt idx="3">
                    <c:v>24.274559114566859</c:v>
                  </c:pt>
                  <c:pt idx="4">
                    <c:v>10.927118899217724</c:v>
                  </c:pt>
                  <c:pt idx="5">
                    <c:v>0.35400406431426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H$26:$M$26</c:f>
              <c:numCache>
                <c:formatCode>General</c:formatCod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</c:numCache>
            </c:numRef>
          </c:cat>
          <c:val>
            <c:numRef>
              <c:f>Sheet1!$H$31:$M$31</c:f>
              <c:numCache>
                <c:formatCode>General</c:formatCode>
                <c:ptCount val="6"/>
                <c:pt idx="0">
                  <c:v>100</c:v>
                </c:pt>
                <c:pt idx="1">
                  <c:v>86.507936507936506</c:v>
                </c:pt>
                <c:pt idx="2">
                  <c:v>69.320436507936506</c:v>
                </c:pt>
                <c:pt idx="3">
                  <c:v>58.730158730158735</c:v>
                </c:pt>
                <c:pt idx="4">
                  <c:v>37.797619047619051</c:v>
                </c:pt>
                <c:pt idx="5">
                  <c:v>0.550595238095238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46F-47D5-8353-9492DC4D3FF1}"/>
            </c:ext>
          </c:extLst>
        </c:ser>
        <c:ser>
          <c:idx val="2"/>
          <c:order val="1"/>
          <c:tx>
            <c:strRef>
              <c:f>Sheet1!$G$39</c:f>
              <c:strCache>
                <c:ptCount val="1"/>
                <c:pt idx="0">
                  <c:v>E.coli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H$26:$M$26</c:f>
              <c:numCache>
                <c:formatCode>General</c:formatCod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</c:numCache>
            </c:numRef>
          </c:cat>
          <c:val>
            <c:numRef>
              <c:f>Sheet1!$H$39:$M$39</c:f>
              <c:numCache>
                <c:formatCode>General</c:formatCode>
                <c:ptCount val="6"/>
                <c:pt idx="0">
                  <c:v>100</c:v>
                </c:pt>
                <c:pt idx="1">
                  <c:v>1E-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46F-47D5-8353-9492DC4D3FF1}"/>
            </c:ext>
          </c:extLst>
        </c:ser>
        <c:ser>
          <c:idx val="3"/>
          <c:order val="2"/>
          <c:tx>
            <c:strRef>
              <c:f>Sheet1!$G$42</c:f>
              <c:strCache>
                <c:ptCount val="1"/>
                <c:pt idx="0">
                  <c:v>D. radiodurans R1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7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43:$M$4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70710678118654802</c:v>
                  </c:pt>
                  <c:pt idx="2">
                    <c:v>1.4142135623730963</c:v>
                  </c:pt>
                  <c:pt idx="3">
                    <c:v>0.70710678118654813</c:v>
                  </c:pt>
                  <c:pt idx="4">
                    <c:v>0.70710678118654813</c:v>
                  </c:pt>
                  <c:pt idx="5">
                    <c:v>7.0710678118654977</c:v>
                  </c:pt>
                </c:numCache>
              </c:numRef>
            </c:plus>
            <c:minus>
              <c:numRef>
                <c:f>Sheet1!$H$43:$M$4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70710678118654802</c:v>
                  </c:pt>
                  <c:pt idx="2">
                    <c:v>1.4142135623730963</c:v>
                  </c:pt>
                  <c:pt idx="3">
                    <c:v>0.70710678118654813</c:v>
                  </c:pt>
                  <c:pt idx="4">
                    <c:v>0.70710678118654813</c:v>
                  </c:pt>
                  <c:pt idx="5">
                    <c:v>7.07106781186549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H$26:$M$26</c:f>
              <c:numCache>
                <c:formatCode>General</c:formatCod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</c:numCache>
            </c:numRef>
          </c:cat>
          <c:val>
            <c:numRef>
              <c:f>Sheet1!$H$42:$M$42</c:f>
              <c:numCache>
                <c:formatCode>General</c:formatCode>
                <c:ptCount val="6"/>
                <c:pt idx="0">
                  <c:v>100</c:v>
                </c:pt>
                <c:pt idx="1">
                  <c:v>89.5</c:v>
                </c:pt>
                <c:pt idx="2">
                  <c:v>85</c:v>
                </c:pt>
                <c:pt idx="3">
                  <c:v>80.5</c:v>
                </c:pt>
                <c:pt idx="4">
                  <c:v>71.5</c:v>
                </c:pt>
                <c:pt idx="5">
                  <c:v>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46F-47D5-8353-9492DC4D3F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52306864"/>
        <c:axId val="252313584"/>
      </c:lineChart>
      <c:catAx>
        <c:axId val="2523068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400" b="1" dirty="0"/>
                  <a:t>Dose (</a:t>
                </a:r>
                <a:r>
                  <a:rPr lang="en-US" altLang="ko-KR" sz="1400" b="1" dirty="0" err="1"/>
                  <a:t>kGy</a:t>
                </a:r>
                <a:r>
                  <a:rPr lang="en-US" altLang="ko-KR" sz="1400" b="1" dirty="0"/>
                  <a:t>)</a:t>
                </a:r>
                <a:endParaRPr lang="ko-KR" altLang="en-US" sz="1400" b="1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52313584"/>
        <c:crosses val="autoZero"/>
        <c:auto val="1"/>
        <c:lblAlgn val="ctr"/>
        <c:lblOffset val="100"/>
        <c:noMultiLvlLbl val="0"/>
      </c:catAx>
      <c:valAx>
        <c:axId val="252313584"/>
        <c:scaling>
          <c:logBase val="10"/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400" b="1" dirty="0"/>
                  <a:t>Survival fraction (log</a:t>
                </a:r>
                <a:r>
                  <a:rPr lang="en-US" altLang="ko-KR" sz="1400" b="1" baseline="-25000" dirty="0"/>
                  <a:t>10</a:t>
                </a:r>
                <a:r>
                  <a:rPr lang="en-US" altLang="ko-KR" sz="1400" b="1" dirty="0"/>
                  <a:t>)</a:t>
                </a:r>
                <a:endParaRPr lang="ko-KR" altLang="en-US" sz="1400" b="1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5230686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19050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2!$N$2</c:f>
              <c:strCache>
                <c:ptCount val="1"/>
                <c:pt idx="0">
                  <c:v>ES10-3-2-2</c:v>
                </c:pt>
              </c:strCache>
            </c:strRef>
          </c:tx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cat>
            <c:numRef>
              <c:f>Sheet2!$O$1:$S$1</c:f>
              <c:numCache>
                <c:formatCode>General</c:formatCode>
                <c:ptCount val="5"/>
                <c:pt idx="0">
                  <c:v>0</c:v>
                </c:pt>
                <c:pt idx="1">
                  <c:v>100</c:v>
                </c:pt>
                <c:pt idx="2">
                  <c:v>300</c:v>
                </c:pt>
                <c:pt idx="3">
                  <c:v>600</c:v>
                </c:pt>
                <c:pt idx="4">
                  <c:v>800</c:v>
                </c:pt>
              </c:numCache>
            </c:numRef>
          </c:cat>
          <c:val>
            <c:numRef>
              <c:f>Sheet2!$O$2:$S$2</c:f>
              <c:numCache>
                <c:formatCode>General</c:formatCode>
                <c:ptCount val="5"/>
                <c:pt idx="0">
                  <c:v>1</c:v>
                </c:pt>
                <c:pt idx="1">
                  <c:v>0.7857142857142857</c:v>
                </c:pt>
                <c:pt idx="2">
                  <c:v>0.5357142857142857</c:v>
                </c:pt>
                <c:pt idx="3">
                  <c:v>0.4107142857142857</c:v>
                </c:pt>
                <c:pt idx="4">
                  <c:v>0.33928571428571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76A-4725-BCCA-6766C7296452}"/>
            </c:ext>
          </c:extLst>
        </c:ser>
        <c:ser>
          <c:idx val="2"/>
          <c:order val="1"/>
          <c:tx>
            <c:strRef>
              <c:f>Sheet2!$N$4</c:f>
              <c:strCache>
                <c:ptCount val="1"/>
                <c:pt idx="0">
                  <c:v>D. radiodurans R1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chemeClr val="tx1"/>
              </a:solidFill>
              <a:ln w="9525">
                <a:solidFill>
                  <a:schemeClr val="tx1">
                    <a:alpha val="94000"/>
                  </a:schemeClr>
                </a:solidFill>
              </a:ln>
              <a:effectLst/>
            </c:spPr>
          </c:marker>
          <c:cat>
            <c:numRef>
              <c:f>Sheet2!$O$1:$S$1</c:f>
              <c:numCache>
                <c:formatCode>General</c:formatCode>
                <c:ptCount val="5"/>
                <c:pt idx="0">
                  <c:v>0</c:v>
                </c:pt>
                <c:pt idx="1">
                  <c:v>100</c:v>
                </c:pt>
                <c:pt idx="2">
                  <c:v>300</c:v>
                </c:pt>
                <c:pt idx="3">
                  <c:v>600</c:v>
                </c:pt>
                <c:pt idx="4">
                  <c:v>800</c:v>
                </c:pt>
              </c:numCache>
            </c:numRef>
          </c:cat>
          <c:val>
            <c:numRef>
              <c:f>Sheet2!$O$4:$S$4</c:f>
              <c:numCache>
                <c:formatCode>General</c:formatCode>
                <c:ptCount val="5"/>
                <c:pt idx="0">
                  <c:v>1</c:v>
                </c:pt>
                <c:pt idx="1">
                  <c:v>0.76388888888888884</c:v>
                </c:pt>
                <c:pt idx="2">
                  <c:v>2.8541666666666667E-2</c:v>
                </c:pt>
                <c:pt idx="3">
                  <c:v>5.8333333333333327E-4</c:v>
                </c:pt>
                <c:pt idx="4">
                  <c:v>4.6527777777777781E-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76A-4725-BCCA-6766C7296452}"/>
            </c:ext>
          </c:extLst>
        </c:ser>
        <c:ser>
          <c:idx val="3"/>
          <c:order val="2"/>
          <c:tx>
            <c:strRef>
              <c:f>Sheet2!$N$5</c:f>
              <c:strCache>
                <c:ptCount val="1"/>
                <c:pt idx="0">
                  <c:v>E.coli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x"/>
            <c:size val="8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2!$O$1:$S$1</c:f>
              <c:numCache>
                <c:formatCode>General</c:formatCode>
                <c:ptCount val="5"/>
                <c:pt idx="0">
                  <c:v>0</c:v>
                </c:pt>
                <c:pt idx="1">
                  <c:v>100</c:v>
                </c:pt>
                <c:pt idx="2">
                  <c:v>300</c:v>
                </c:pt>
                <c:pt idx="3">
                  <c:v>600</c:v>
                </c:pt>
                <c:pt idx="4">
                  <c:v>800</c:v>
                </c:pt>
              </c:numCache>
            </c:numRef>
          </c:cat>
          <c:val>
            <c:numRef>
              <c:f>Sheet2!$O$5:$S$5</c:f>
              <c:numCache>
                <c:formatCode>General</c:formatCode>
                <c:ptCount val="5"/>
                <c:pt idx="0">
                  <c:v>1</c:v>
                </c:pt>
                <c:pt idx="1">
                  <c:v>9.9999999999999995E-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076A-4725-BCCA-6766C72964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74503472"/>
        <c:axId val="214189760"/>
      </c:lineChart>
      <c:catAx>
        <c:axId val="4745034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i="0" baseline="0" dirty="0">
                    <a:effectLst/>
                  </a:rPr>
                  <a:t>Dose (J/m</a:t>
                </a:r>
                <a:r>
                  <a:rPr lang="en-US" sz="1800" b="1" i="0" baseline="30000" dirty="0">
                    <a:effectLst/>
                  </a:rPr>
                  <a:t>2</a:t>
                </a:r>
                <a:r>
                  <a:rPr lang="en-US" sz="1800" b="1" i="0" baseline="0" dirty="0">
                    <a:effectLst/>
                  </a:rPr>
                  <a:t>/s)</a:t>
                </a:r>
                <a:endParaRPr lang="en-US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189760"/>
        <c:crosses val="autoZero"/>
        <c:auto val="1"/>
        <c:lblAlgn val="ctr"/>
        <c:lblOffset val="100"/>
        <c:noMultiLvlLbl val="0"/>
      </c:catAx>
      <c:valAx>
        <c:axId val="214189760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i="0" baseline="0">
                    <a:effectLst/>
                  </a:rPr>
                  <a:t>Survival fraction (log</a:t>
                </a:r>
                <a:r>
                  <a:rPr lang="en-US" sz="1800" b="1" i="0" baseline="-25000">
                    <a:effectLst/>
                  </a:rPr>
                  <a:t>10</a:t>
                </a:r>
                <a:r>
                  <a:rPr lang="en-US" sz="1800" b="1" i="0" baseline="0">
                    <a:effectLst/>
                  </a:rPr>
                  <a:t>)</a:t>
                </a:r>
                <a:endParaRPr lang="en-US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45034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2877F2-EF55-49A3-AF97-83753C1AA6B4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6E7F7E-04C4-488D-AA43-AE99014B6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5765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. Figure S7.  Radiation. Representative survival curve of strain  ES10-3-2-2 following exposure to (A) gamma </a:t>
            </a:r>
            <a:r>
              <a:rPr lang="en-US" dirty="0" err="1"/>
              <a:t>irradaition</a:t>
            </a:r>
            <a:r>
              <a:rPr lang="en-US" dirty="0"/>
              <a:t> (0~10kGy) and (B) UV radiation (0~800 J/m2) with a positive control, </a:t>
            </a:r>
            <a:r>
              <a:rPr lang="en-US" i="1" dirty="0"/>
              <a:t>D. radiodurans R1</a:t>
            </a:r>
            <a:r>
              <a:rPr lang="en-US" dirty="0"/>
              <a:t> and a negative control, Escherichia coli K-12. Each increment on the y-axis represents a tenfold reduction in viability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36E7F7E-04C4-488D-AA43-AE99014B637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9704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3C6581-46AB-1927-A4FC-DCD4DB5D7B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F9E801-C5EC-9150-E18C-E019E00575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430FFD-7A82-E655-5DCA-E41474FCB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A2FA04-1B8D-6AF8-4D72-8AD5A7089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62F0F5-27AA-A325-0954-B19A888A4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368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459820-DAB5-0760-250C-947375971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4168D4-F0B8-6A1D-F5E6-011A94F3B5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2780AE-65BF-F66A-1CC4-2B0956E06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EAB49A-62C5-6A1B-3D0E-0369B5D7B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9DD67B-871B-0E83-4937-94BDD7399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280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D2C880-07AA-760E-40A4-8FDA7F6970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42EAD0-4867-32CC-FB9E-E8F7676C17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E2F98-2D67-954E-2B32-070C99CF5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D10130-359C-02B7-2446-D89D34BB1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8FA255-32D2-BAD3-D338-00E315155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411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6A46B5-26C4-33C8-2CFA-3DFDAFE5E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3515D9-8854-27A4-98CA-ECCEA61902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1E3C79-B123-88FE-26CA-E5BDE77D8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6850C2-51C8-F217-97F4-9F69A1EE8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3B43D4-0520-0233-AB93-51C6821E1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058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BC1A26-2274-79FC-556E-6A9B939C00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97B6F3-FC42-1AB7-776C-2DF33737B7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BF56C2-0F03-886C-38BD-E9375A756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6127C1-0A65-23AF-1FE9-9A3989759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AE682A-9ACF-0204-4251-E146504DA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414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183D2A-C437-950A-961A-A21BF2B34D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742AE7-7876-792F-E2A1-B5CD1DE31F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8C2598-A685-A1AD-7F35-6C08128550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B7C5A8-4372-85B9-E679-ACEC50879B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BCA63C-73FC-183E-914F-CCFD79EC1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BD9D81-26B3-2305-1A3B-E2427B3F6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416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2868E2-FEB7-4B1B-15E1-796355910C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ED166D-787B-A7CD-6A10-F32627049A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17D10B-E07D-2797-D12A-067DBBA458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00D2856-E8EC-0FF5-8751-855A81C2E3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032F173-8200-45B5-BE22-17D7F95EE7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1554929-6ED5-805C-3388-D9D463591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9B02356-4423-E9EC-7805-BAD9B7937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2360A9A-637F-E018-6E63-469666F63D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052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7D396D-5A76-23F8-985D-9D6E970D17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4D0CC03-82C9-E8B1-C0A0-A6E73057F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28F9DAB-6CE0-61EA-9C5D-E3A0F90FFD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C14546-4072-50CB-8B4F-CFAC44FC7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013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AEA35B-C875-4919-AE98-A8CB476A7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EF4332-0CBE-3180-7177-789D4E1BA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B6E600-0FE8-CB1F-A104-DF2103F9B7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435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96B782-06D0-6BB1-8426-6366D2E94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3E8FC4-DED9-6009-F12D-9D572CC1A7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1ABFA5-311F-524E-78EE-2D3573E6EA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A32047-6306-21F6-D221-E5786AB5B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928C3E-DC3F-221B-1E7C-E621D3535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8D5406-5C1C-5291-BC14-54F7DC28D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18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339CF3-434B-51E3-95E7-9BE77FE251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E34109-920A-996D-AC87-A263C172B3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3605B7-2A02-1930-72FC-DB7056CF51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0AF8F7-7E1A-4C5C-6020-2192BBE7B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74C30B-138D-BEE7-3D1F-BF2195AF5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FCDAAE-6CC5-7947-E3A9-FFFB9372D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886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A8F017-5CEF-85BA-A215-667601ECA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2BC52C-8EAE-4115-9F88-FBF4F4CECC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F92625-684D-8698-D925-F2B45D896C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05218-A841-4E88-982E-8D613A52DC92}" type="datetimeFigureOut">
              <a:rPr lang="en-US" smtClean="0"/>
              <a:t>5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77DC74-14F9-4F35-4332-BFC1F71D0D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C9D19E-7E39-0DAE-7A15-457776C2AE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269248-6CE5-428A-89DD-F3612E049B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731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8">
            <a:extLst>
              <a:ext uri="{FF2B5EF4-FFF2-40B4-BE49-F238E27FC236}">
                <a16:creationId xmlns:a16="http://schemas.microsoft.com/office/drawing/2014/main" id="{00000000-0008-0000-0000-000009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1573534"/>
              </p:ext>
            </p:extLst>
          </p:nvPr>
        </p:nvGraphicFramePr>
        <p:xfrm>
          <a:off x="229525" y="1542118"/>
          <a:ext cx="5783551" cy="37737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차트 2">
            <a:extLst>
              <a:ext uri="{FF2B5EF4-FFF2-40B4-BE49-F238E27FC236}">
                <a16:creationId xmlns:a16="http://schemas.microsoft.com/office/drawing/2014/main" id="{00000000-0008-0000-01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3497471"/>
              </p:ext>
            </p:extLst>
          </p:nvPr>
        </p:nvGraphicFramePr>
        <p:xfrm>
          <a:off x="6284265" y="1581608"/>
          <a:ext cx="5783551" cy="37737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A47120C-A406-8035-FE7F-C820B90A1310}"/>
              </a:ext>
            </a:extLst>
          </p:cNvPr>
          <p:cNvSpPr txBox="1"/>
          <p:nvPr/>
        </p:nvSpPr>
        <p:spPr>
          <a:xfrm>
            <a:off x="229525" y="1080453"/>
            <a:ext cx="4667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177FF47-AD3A-4077-DDE8-DF24F8FE6691}"/>
              </a:ext>
            </a:extLst>
          </p:cNvPr>
          <p:cNvSpPr txBox="1"/>
          <p:nvPr/>
        </p:nvSpPr>
        <p:spPr>
          <a:xfrm>
            <a:off x="6284265" y="1080452"/>
            <a:ext cx="4539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864686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93</Words>
  <Application>Microsoft Office PowerPoint</Application>
  <PresentationFormat>Widescreen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nivasan sathiyaraj</dc:creator>
  <cp:lastModifiedBy>sathiyaraj srinivasan</cp:lastModifiedBy>
  <cp:revision>5</cp:revision>
  <dcterms:created xsi:type="dcterms:W3CDTF">2022-07-18T14:58:59Z</dcterms:created>
  <dcterms:modified xsi:type="dcterms:W3CDTF">2024-05-09T17:51:04Z</dcterms:modified>
</cp:coreProperties>
</file>